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8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292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L$31</c:f>
              <c:strCache>
                <c:ptCount val="1"/>
                <c:pt idx="0">
                  <c:v>FASN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M$32:$M$35</c:f>
                <c:numCache>
                  <c:formatCode>General</c:formatCode>
                  <c:ptCount val="4"/>
                  <c:pt idx="0">
                    <c:v>0.12039894457317886</c:v>
                  </c:pt>
                  <c:pt idx="1">
                    <c:v>0.13314759727249456</c:v>
                  </c:pt>
                  <c:pt idx="2">
                    <c:v>0.10473704691265207</c:v>
                  </c:pt>
                  <c:pt idx="3">
                    <c:v>0.1935322881957636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1!$K$32:$K$35</c:f>
              <c:numCache>
                <c:formatCode>General</c:formatCode>
                <c:ptCount val="4"/>
                <c:pt idx="0">
                  <c:v>0</c:v>
                </c:pt>
                <c:pt idx="1">
                  <c:v>100</c:v>
                </c:pt>
                <c:pt idx="2">
                  <c:v>200</c:v>
                </c:pt>
                <c:pt idx="3">
                  <c:v>400</c:v>
                </c:pt>
              </c:numCache>
            </c:numRef>
          </c:cat>
          <c:val>
            <c:numRef>
              <c:f>Sheet1!$L$32:$L$35</c:f>
              <c:numCache>
                <c:formatCode>General</c:formatCode>
                <c:ptCount val="4"/>
                <c:pt idx="0">
                  <c:v>1</c:v>
                </c:pt>
                <c:pt idx="1">
                  <c:v>1.3634916202096374</c:v>
                </c:pt>
                <c:pt idx="2">
                  <c:v>1.5755866477584308</c:v>
                </c:pt>
                <c:pt idx="3">
                  <c:v>1.29608328227720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E03-467A-8B9F-88FDE01031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303395336"/>
        <c:axId val="303395728"/>
      </c:barChart>
      <c:catAx>
        <c:axId val="3033953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solidFill>
            <a:schemeClr val="bg1"/>
          </a:solidFill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03395728"/>
        <c:crosses val="autoZero"/>
        <c:auto val="1"/>
        <c:lblAlgn val="ctr"/>
        <c:lblOffset val="100"/>
        <c:noMultiLvlLbl val="0"/>
      </c:catAx>
      <c:valAx>
        <c:axId val="303395728"/>
        <c:scaling>
          <c:orientation val="minMax"/>
        </c:scaling>
        <c:delete val="0"/>
        <c:axPos val="l"/>
        <c:numFmt formatCode="#,##0.0" sourceLinked="0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03395336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7615F5-D1BC-4F15-B11F-8FD551188DCD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6109EF-F822-4831-AF44-035BF186B4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02957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49500" y="1163638"/>
            <a:ext cx="2354263" cy="3141662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62CA37C-5DFD-4879-8318-0724237D613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0078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27194-AF62-4C19-B2FD-86DE97E0145A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7A1038-9914-4653-A160-CA4AC15A6E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5234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27194-AF62-4C19-B2FD-86DE97E0145A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7A1038-9914-4653-A160-CA4AC15A6E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664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27194-AF62-4C19-B2FD-86DE97E0145A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7A1038-9914-4653-A160-CA4AC15A6E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58558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27194-AF62-4C19-B2FD-86DE97E0145A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7A1038-9914-4653-A160-CA4AC15A6E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0824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27194-AF62-4C19-B2FD-86DE97E0145A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7A1038-9914-4653-A160-CA4AC15A6E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96311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27194-AF62-4C19-B2FD-86DE97E0145A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7A1038-9914-4653-A160-CA4AC15A6E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2473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27194-AF62-4C19-B2FD-86DE97E0145A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7A1038-9914-4653-A160-CA4AC15A6E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8762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27194-AF62-4C19-B2FD-86DE97E0145A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7A1038-9914-4653-A160-CA4AC15A6E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71450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27194-AF62-4C19-B2FD-86DE97E0145A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7A1038-9914-4653-A160-CA4AC15A6E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27922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27194-AF62-4C19-B2FD-86DE97E0145A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7A1038-9914-4653-A160-CA4AC15A6E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46605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27194-AF62-4C19-B2FD-86DE97E0145A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7A1038-9914-4653-A160-CA4AC15A6E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91412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727194-AF62-4C19-B2FD-86DE97E0145A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7A1038-9914-4653-A160-CA4AC15A6E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00779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3" Type="http://schemas.openxmlformats.org/officeDocument/2006/relationships/image" Target="../media/image1.emf"/><Relationship Id="rId7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10" Type="http://schemas.openxmlformats.org/officeDocument/2006/relationships/image" Target="../media/image7.emf"/><Relationship Id="rId4" Type="http://schemas.openxmlformats.org/officeDocument/2006/relationships/image" Target="../media/image2.emf"/><Relationship Id="rId9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E1495A0-D5A2-4A74-B94B-7C957A439574}"/>
              </a:ext>
            </a:extLst>
          </p:cNvPr>
          <p:cNvPicPr>
            <a:picLocks noChangeAspect="1"/>
          </p:cNvPicPr>
          <p:nvPr/>
        </p:nvPicPr>
        <p:blipFill>
          <a:blip r:embed="rId3">
            <a:lum contrast="40000"/>
          </a:blip>
          <a:stretch>
            <a:fillRect/>
          </a:stretch>
        </p:blipFill>
        <p:spPr>
          <a:xfrm>
            <a:off x="3265862" y="6708188"/>
            <a:ext cx="2402959" cy="33407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DAFFE68-6EA5-4409-B3E1-7A8270BF18C4}"/>
              </a:ext>
            </a:extLst>
          </p:cNvPr>
          <p:cNvPicPr>
            <a:picLocks noChangeAspect="1"/>
          </p:cNvPicPr>
          <p:nvPr/>
        </p:nvPicPr>
        <p:blipFill>
          <a:blip r:embed="rId4">
            <a:lum contrast="40000"/>
          </a:blip>
          <a:stretch>
            <a:fillRect/>
          </a:stretch>
        </p:blipFill>
        <p:spPr>
          <a:xfrm>
            <a:off x="3280760" y="8157826"/>
            <a:ext cx="2402959" cy="33407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D52DC53-D8D9-4191-8497-E099736A8678}"/>
              </a:ext>
            </a:extLst>
          </p:cNvPr>
          <p:cNvSpPr txBox="1"/>
          <p:nvPr/>
        </p:nvSpPr>
        <p:spPr>
          <a:xfrm>
            <a:off x="3429626" y="6463336"/>
            <a:ext cx="28769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400       µg/m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39F8B5B-FF62-4E2D-B281-C767F38FAA32}"/>
              </a:ext>
            </a:extLst>
          </p:cNvPr>
          <p:cNvSpPr txBox="1"/>
          <p:nvPr/>
        </p:nvSpPr>
        <p:spPr>
          <a:xfrm>
            <a:off x="5617390" y="6737092"/>
            <a:ext cx="5945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FAS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9E63842-E6BD-4A1A-8299-3FCE4E204B25}"/>
              </a:ext>
            </a:extLst>
          </p:cNvPr>
          <p:cNvSpPr txBox="1"/>
          <p:nvPr/>
        </p:nvSpPr>
        <p:spPr>
          <a:xfrm>
            <a:off x="5617394" y="8182600"/>
            <a:ext cx="7655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161B2DC2-47FF-4DAA-B641-D97C530575FF}"/>
              </a:ext>
            </a:extLst>
          </p:cNvPr>
          <p:cNvPicPr>
            <a:picLocks noChangeAspect="1"/>
          </p:cNvPicPr>
          <p:nvPr/>
        </p:nvPicPr>
        <p:blipFill>
          <a:blip r:embed="rId5">
            <a:lum bright="20000" contrast="40000"/>
          </a:blip>
          <a:stretch>
            <a:fillRect/>
          </a:stretch>
        </p:blipFill>
        <p:spPr>
          <a:xfrm>
            <a:off x="3259724" y="7191793"/>
            <a:ext cx="2409097" cy="31178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534544EA-47E2-4F97-BA64-32331C69C886}"/>
              </a:ext>
            </a:extLst>
          </p:cNvPr>
          <p:cNvPicPr>
            <a:picLocks noChangeAspect="1"/>
          </p:cNvPicPr>
          <p:nvPr/>
        </p:nvPicPr>
        <p:blipFill>
          <a:blip r:embed="rId6">
            <a:lum bright="20000" contrast="40000"/>
          </a:blip>
          <a:stretch>
            <a:fillRect/>
          </a:stretch>
        </p:blipFill>
        <p:spPr>
          <a:xfrm>
            <a:off x="3276409" y="7686962"/>
            <a:ext cx="2407308" cy="32085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DA614190-A789-4EE8-8052-DCA5323F24E6}"/>
              </a:ext>
            </a:extLst>
          </p:cNvPr>
          <p:cNvSpPr txBox="1"/>
          <p:nvPr/>
        </p:nvSpPr>
        <p:spPr>
          <a:xfrm>
            <a:off x="5618833" y="7217918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-AK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8E60A11-E9D0-4495-906C-D3366CBCCF1F}"/>
              </a:ext>
            </a:extLst>
          </p:cNvPr>
          <p:cNvSpPr txBox="1"/>
          <p:nvPr/>
        </p:nvSpPr>
        <p:spPr>
          <a:xfrm>
            <a:off x="5630870" y="7713496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it-I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8C10D75-2AC9-4CCA-8FD6-0874777B66A7}"/>
              </a:ext>
            </a:extLst>
          </p:cNvPr>
          <p:cNvSpPr txBox="1"/>
          <p:nvPr/>
        </p:nvSpPr>
        <p:spPr>
          <a:xfrm>
            <a:off x="3229093" y="7001669"/>
            <a:ext cx="25512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±0.1     1.1±0.1     0.8±0.1     0.6*±0.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21475D8-4491-482E-8DBB-06A3D60309A8}"/>
              </a:ext>
            </a:extLst>
          </p:cNvPr>
          <p:cNvSpPr txBox="1"/>
          <p:nvPr/>
        </p:nvSpPr>
        <p:spPr>
          <a:xfrm>
            <a:off x="3229090" y="7971371"/>
            <a:ext cx="28548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±0.1      1.1±0.1      1.1±0.1     1.1±0.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E82C8D7-348B-4A39-9B5E-6DDD80DAEA43}"/>
              </a:ext>
            </a:extLst>
          </p:cNvPr>
          <p:cNvSpPr txBox="1"/>
          <p:nvPr/>
        </p:nvSpPr>
        <p:spPr>
          <a:xfrm>
            <a:off x="-28169" y="5687477"/>
            <a:ext cx="504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210D2CA-7F5F-419E-A8B7-4C50892AC129}"/>
              </a:ext>
            </a:extLst>
          </p:cNvPr>
          <p:cNvSpPr txBox="1"/>
          <p:nvPr/>
        </p:nvSpPr>
        <p:spPr>
          <a:xfrm>
            <a:off x="3229093" y="7469083"/>
            <a:ext cx="27482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±0.1    2.6±0.1**   3.6±0.1Ɨ     4.8±0.2Ɨ</a:t>
            </a:r>
          </a:p>
        </p:txBody>
      </p:sp>
      <p:grpSp>
        <p:nvGrpSpPr>
          <p:cNvPr id="46" name="Group 45">
            <a:extLst>
              <a:ext uri="{FF2B5EF4-FFF2-40B4-BE49-F238E27FC236}">
                <a16:creationId xmlns:a16="http://schemas.microsoft.com/office/drawing/2014/main" id="{E144C780-E6F8-4E56-8935-48DB153B75C5}"/>
              </a:ext>
            </a:extLst>
          </p:cNvPr>
          <p:cNvGrpSpPr/>
          <p:nvPr/>
        </p:nvGrpSpPr>
        <p:grpSpPr>
          <a:xfrm>
            <a:off x="563359" y="5790887"/>
            <a:ext cx="3037204" cy="2884744"/>
            <a:chOff x="563355" y="6227333"/>
            <a:chExt cx="3037204" cy="2460288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06D0D232-097E-44E0-ABFF-430C3E0D87E9}"/>
                </a:ext>
              </a:extLst>
            </p:cNvPr>
            <p:cNvSpPr txBox="1"/>
            <p:nvPr/>
          </p:nvSpPr>
          <p:spPr>
            <a:xfrm rot="16200000">
              <a:off x="-385323" y="7176011"/>
              <a:ext cx="235902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Fasn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mRNA level</a:t>
              </a: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relative to C)</a:t>
              </a:r>
            </a:p>
          </p:txBody>
        </p:sp>
        <p:graphicFrame>
          <p:nvGraphicFramePr>
            <p:cNvPr id="17" name="Chart 16">
              <a:extLst>
                <a:ext uri="{FF2B5EF4-FFF2-40B4-BE49-F238E27FC236}">
                  <a16:creationId xmlns:a16="http://schemas.microsoft.com/office/drawing/2014/main" id="{6DBF1EED-AE54-4FDA-9B28-F27D79EF086C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953238" y="6463769"/>
            <a:ext cx="1887573" cy="188615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0BC47E36-D389-4C93-A9F7-ACBFA49DF9A7}"/>
                </a:ext>
              </a:extLst>
            </p:cNvPr>
            <p:cNvGrpSpPr/>
            <p:nvPr/>
          </p:nvGrpSpPr>
          <p:grpSpPr>
            <a:xfrm>
              <a:off x="1395439" y="8222389"/>
              <a:ext cx="2205120" cy="465232"/>
              <a:chOff x="1180984" y="8044471"/>
              <a:chExt cx="2205120" cy="465232"/>
            </a:xfrm>
          </p:grpSpPr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6DBDCAF7-18B0-4F68-92C3-4F43A132FDFD}"/>
                  </a:ext>
                </a:extLst>
              </p:cNvPr>
              <p:cNvSpPr txBox="1"/>
              <p:nvPr/>
            </p:nvSpPr>
            <p:spPr>
              <a:xfrm>
                <a:off x="1180984" y="8044471"/>
                <a:ext cx="2205120" cy="236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  100  200  400</a:t>
                </a:r>
              </a:p>
            </p:txBody>
          </p:sp>
          <p:sp>
            <p:nvSpPr>
              <p:cNvPr id="22" name="Right Bracket 21">
                <a:extLst>
                  <a:ext uri="{FF2B5EF4-FFF2-40B4-BE49-F238E27FC236}">
                    <a16:creationId xmlns:a16="http://schemas.microsoft.com/office/drawing/2014/main" id="{753D000F-5358-4B84-B0A9-B9ECED69D2F3}"/>
                  </a:ext>
                </a:extLst>
              </p:cNvPr>
              <p:cNvSpPr/>
              <p:nvPr/>
            </p:nvSpPr>
            <p:spPr>
              <a:xfrm rot="5400000">
                <a:off x="1970510" y="7778556"/>
                <a:ext cx="45719" cy="970387"/>
              </a:xfrm>
              <a:prstGeom prst="righ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BE522AFC-48F8-469E-8DF4-A537A9888E56}"/>
                  </a:ext>
                </a:extLst>
              </p:cNvPr>
              <p:cNvSpPr txBox="1"/>
              <p:nvPr/>
            </p:nvSpPr>
            <p:spPr>
              <a:xfrm>
                <a:off x="1668997" y="8273461"/>
                <a:ext cx="712519" cy="2362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/mL</a:t>
                </a:r>
              </a:p>
            </p:txBody>
          </p:sp>
        </p:grp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89F0D45-E088-47A9-8238-02DE89BDB73C}"/>
                </a:ext>
              </a:extLst>
            </p:cNvPr>
            <p:cNvSpPr txBox="1"/>
            <p:nvPr/>
          </p:nvSpPr>
          <p:spPr>
            <a:xfrm>
              <a:off x="2004800" y="6582716"/>
              <a:ext cx="406047" cy="3149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8" name="Right Bracket 27">
              <a:extLst>
                <a:ext uri="{FF2B5EF4-FFF2-40B4-BE49-F238E27FC236}">
                  <a16:creationId xmlns:a16="http://schemas.microsoft.com/office/drawing/2014/main" id="{88D41DD8-B3BB-413D-BBF5-81A7CE19EEDC}"/>
                </a:ext>
              </a:extLst>
            </p:cNvPr>
            <p:cNvSpPr/>
            <p:nvPr/>
          </p:nvSpPr>
          <p:spPr>
            <a:xfrm rot="5400000" flipH="1">
              <a:off x="2147005" y="6409759"/>
              <a:ext cx="111532" cy="829844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9" name="TextBox 28">
            <a:extLst>
              <a:ext uri="{FF2B5EF4-FFF2-40B4-BE49-F238E27FC236}">
                <a16:creationId xmlns:a16="http://schemas.microsoft.com/office/drawing/2014/main" id="{9293D1FC-70C3-47CF-A708-8D734C8CC60F}"/>
              </a:ext>
            </a:extLst>
          </p:cNvPr>
          <p:cNvSpPr txBox="1"/>
          <p:nvPr/>
        </p:nvSpPr>
        <p:spPr>
          <a:xfrm>
            <a:off x="3379461" y="6265114"/>
            <a:ext cx="2606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u="sng" dirty="0">
                <a:latin typeface="Arial" panose="020B0604020202020204" pitchFamily="34" charset="0"/>
                <a:cs typeface="Arial" panose="020B0604020202020204" pitchFamily="34" charset="0"/>
              </a:rPr>
              <a:t>Vermentino EtOH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210C2FA0-5234-4EC4-B45B-E4F267CB181A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4499" t="-1" r="44133" b="2687"/>
          <a:stretch/>
        </p:blipFill>
        <p:spPr>
          <a:xfrm>
            <a:off x="3517974" y="1407696"/>
            <a:ext cx="1769138" cy="3851883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F35FD7CD-608C-4AB6-A771-D20D93A04A93}"/>
              </a:ext>
            </a:extLst>
          </p:cNvPr>
          <p:cNvSpPr txBox="1"/>
          <p:nvPr/>
        </p:nvSpPr>
        <p:spPr>
          <a:xfrm>
            <a:off x="3795882" y="5287045"/>
            <a:ext cx="13049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tention Time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349FFC9-6A4A-4C53-80BC-69E0AF7875E3}"/>
              </a:ext>
            </a:extLst>
          </p:cNvPr>
          <p:cNvSpPr txBox="1"/>
          <p:nvPr/>
        </p:nvSpPr>
        <p:spPr>
          <a:xfrm>
            <a:off x="3106124" y="2456188"/>
            <a:ext cx="369332" cy="1513558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6501920-ADFE-4FB3-BAD5-C3A49E2C3F5B}"/>
              </a:ext>
            </a:extLst>
          </p:cNvPr>
          <p:cNvSpPr txBox="1"/>
          <p:nvPr/>
        </p:nvSpPr>
        <p:spPr>
          <a:xfrm>
            <a:off x="1443962" y="5278889"/>
            <a:ext cx="13049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tention Tim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616F4A2-FE3F-43A3-946E-8C9AB9773C11}"/>
              </a:ext>
            </a:extLst>
          </p:cNvPr>
          <p:cNvSpPr txBox="1"/>
          <p:nvPr/>
        </p:nvSpPr>
        <p:spPr>
          <a:xfrm>
            <a:off x="676569" y="2432124"/>
            <a:ext cx="369332" cy="1513558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35212325-116A-4592-8F6C-CBA8725B53B2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192" r="40378" b="3273"/>
          <a:stretch/>
        </p:blipFill>
        <p:spPr>
          <a:xfrm>
            <a:off x="1064856" y="1418448"/>
            <a:ext cx="1769138" cy="3812831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33BC4B10-2C00-489D-80E2-CB3363C3AC80}"/>
              </a:ext>
            </a:extLst>
          </p:cNvPr>
          <p:cNvSpPr txBox="1"/>
          <p:nvPr/>
        </p:nvSpPr>
        <p:spPr>
          <a:xfrm>
            <a:off x="3503621" y="1009968"/>
            <a:ext cx="20764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Vermentino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tOH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F84572C-09F3-41B8-9B5C-B51331879474}"/>
              </a:ext>
            </a:extLst>
          </p:cNvPr>
          <p:cNvSpPr txBox="1"/>
          <p:nvPr/>
        </p:nvSpPr>
        <p:spPr>
          <a:xfrm>
            <a:off x="932986" y="1102302"/>
            <a:ext cx="1943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F448F95E-7D2F-45C4-8772-C7015E93EE9B}"/>
              </a:ext>
            </a:extLst>
          </p:cNvPr>
          <p:cNvSpPr/>
          <p:nvPr/>
        </p:nvSpPr>
        <p:spPr>
          <a:xfrm>
            <a:off x="2733907" y="91907"/>
            <a:ext cx="1481559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ASN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VTAIHIDPATHR</a:t>
            </a:r>
          </a:p>
        </p:txBody>
      </p:sp>
      <p:pic>
        <p:nvPicPr>
          <p:cNvPr id="45" name="Picture 44">
            <a:extLst>
              <a:ext uri="{FF2B5EF4-FFF2-40B4-BE49-F238E27FC236}">
                <a16:creationId xmlns:a16="http://schemas.microsoft.com/office/drawing/2014/main" id="{4ACAFC29-DD42-4399-9B65-89D9D4E51EAA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9174" t="1691" r="5557" b="95698"/>
          <a:stretch/>
        </p:blipFill>
        <p:spPr>
          <a:xfrm>
            <a:off x="683189" y="618009"/>
            <a:ext cx="5444481" cy="219642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ECEB1848-F18A-4071-8D05-DB07A3B8B1C9}"/>
              </a:ext>
            </a:extLst>
          </p:cNvPr>
          <p:cNvSpPr txBox="1"/>
          <p:nvPr/>
        </p:nvSpPr>
        <p:spPr>
          <a:xfrm>
            <a:off x="8242" y="112326"/>
            <a:ext cx="7742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DEE5DF4C-B997-44F2-8AB0-AFAFC386C90F}"/>
              </a:ext>
            </a:extLst>
          </p:cNvPr>
          <p:cNvSpPr txBox="1"/>
          <p:nvPr/>
        </p:nvSpPr>
        <p:spPr>
          <a:xfrm>
            <a:off x="3750607" y="8716689"/>
            <a:ext cx="37584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6A10A3C-528D-4CBA-8689-D16493D63609}"/>
              </a:ext>
            </a:extLst>
          </p:cNvPr>
          <p:cNvSpPr txBox="1"/>
          <p:nvPr/>
        </p:nvSpPr>
        <p:spPr>
          <a:xfrm>
            <a:off x="2953595" y="6647160"/>
            <a:ext cx="576393" cy="5842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9" dirty="0">
                <a:latin typeface="Arial" panose="020B0604020202020204" pitchFamily="34" charset="0"/>
                <a:cs typeface="Arial" panose="020B0604020202020204" pitchFamily="34" charset="0"/>
              </a:rPr>
              <a:t>245-</a:t>
            </a:r>
          </a:p>
          <a:p>
            <a:endParaRPr lang="en-US" sz="799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799" dirty="0">
                <a:latin typeface="Arial" panose="020B0604020202020204" pitchFamily="34" charset="0"/>
                <a:cs typeface="Arial" panose="020B0604020202020204" pitchFamily="34" charset="0"/>
              </a:rPr>
              <a:t>180-</a:t>
            </a:r>
          </a:p>
          <a:p>
            <a:endParaRPr lang="en-US" sz="7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1439CC2-BFD5-4FBD-A168-9E26F8711DDF}"/>
              </a:ext>
            </a:extLst>
          </p:cNvPr>
          <p:cNvSpPr txBox="1"/>
          <p:nvPr/>
        </p:nvSpPr>
        <p:spPr>
          <a:xfrm>
            <a:off x="3013168" y="7121255"/>
            <a:ext cx="576393" cy="5842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9" dirty="0">
                <a:latin typeface="Arial" panose="020B0604020202020204" pitchFamily="34" charset="0"/>
                <a:cs typeface="Arial" panose="020B0604020202020204" pitchFamily="34" charset="0"/>
              </a:rPr>
              <a:t>63-</a:t>
            </a:r>
          </a:p>
          <a:p>
            <a:endParaRPr lang="en-US" sz="799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799" dirty="0">
                <a:latin typeface="Arial" panose="020B0604020202020204" pitchFamily="34" charset="0"/>
                <a:cs typeface="Arial" panose="020B0604020202020204" pitchFamily="34" charset="0"/>
              </a:rPr>
              <a:t>48-</a:t>
            </a:r>
          </a:p>
          <a:p>
            <a:endParaRPr lang="en-US" sz="7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2F4250F-EAA4-46B0-A1A8-8DED6FB8CC2F}"/>
              </a:ext>
            </a:extLst>
          </p:cNvPr>
          <p:cNvSpPr txBox="1"/>
          <p:nvPr/>
        </p:nvSpPr>
        <p:spPr>
          <a:xfrm>
            <a:off x="3019476" y="7625712"/>
            <a:ext cx="576393" cy="5842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9" dirty="0">
                <a:latin typeface="Arial" panose="020B0604020202020204" pitchFamily="34" charset="0"/>
                <a:cs typeface="Arial" panose="020B0604020202020204" pitchFamily="34" charset="0"/>
              </a:rPr>
              <a:t>63-</a:t>
            </a:r>
          </a:p>
          <a:p>
            <a:endParaRPr lang="en-US" sz="799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799" dirty="0">
                <a:latin typeface="Arial" panose="020B0604020202020204" pitchFamily="34" charset="0"/>
                <a:cs typeface="Arial" panose="020B0604020202020204" pitchFamily="34" charset="0"/>
              </a:rPr>
              <a:t>48-</a:t>
            </a:r>
          </a:p>
          <a:p>
            <a:endParaRPr lang="en-US" sz="7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F4FB967-2628-4939-A2AD-36AB17EA2FB5}"/>
              </a:ext>
            </a:extLst>
          </p:cNvPr>
          <p:cNvSpPr txBox="1"/>
          <p:nvPr/>
        </p:nvSpPr>
        <p:spPr>
          <a:xfrm>
            <a:off x="3040402" y="8106095"/>
            <a:ext cx="576393" cy="5842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9" dirty="0">
                <a:latin typeface="Arial" panose="020B0604020202020204" pitchFamily="34" charset="0"/>
                <a:cs typeface="Arial" panose="020B0604020202020204" pitchFamily="34" charset="0"/>
              </a:rPr>
              <a:t>48-</a:t>
            </a:r>
          </a:p>
          <a:p>
            <a:endParaRPr lang="en-US" sz="799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799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</a:p>
          <a:p>
            <a:endParaRPr lang="en-US" sz="7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11450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5</Words>
  <Application>Microsoft Office PowerPoint</Application>
  <PresentationFormat>On-screen Show (4:3)</PresentationFormat>
  <Paragraphs>3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asi, Maria Lauda</dc:creator>
  <cp:lastModifiedBy>Tomasi, Maria Lauda</cp:lastModifiedBy>
  <cp:revision>1</cp:revision>
  <dcterms:created xsi:type="dcterms:W3CDTF">2020-02-18T21:10:59Z</dcterms:created>
  <dcterms:modified xsi:type="dcterms:W3CDTF">2020-02-18T21:11:38Z</dcterms:modified>
</cp:coreProperties>
</file>